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2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C6B4"/>
    <a:srgbClr val="FF9999"/>
    <a:srgbClr val="FF99CC"/>
    <a:srgbClr val="33CCFF"/>
    <a:srgbClr val="BF95DF"/>
    <a:srgbClr val="9999FF"/>
    <a:srgbClr val="CC99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 horzBarState="maximized">
    <p:restoredLeft sz="7381" autoAdjust="0"/>
    <p:restoredTop sz="94660"/>
  </p:normalViewPr>
  <p:slideViewPr>
    <p:cSldViewPr snapToGrid="0">
      <p:cViewPr varScale="1">
        <p:scale>
          <a:sx n="127" d="100"/>
          <a:sy n="127" d="100"/>
        </p:scale>
        <p:origin x="1432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ZA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8570B69-EB4F-468B-869B-091D6C0418DA}" type="datetimeFigureOut">
              <a:rPr lang="en-ZA" smtClean="0"/>
              <a:t>2021/05/14</a:t>
            </a:fld>
            <a:endParaRPr lang="en-ZA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ZA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299156D-F2AA-470E-BEB3-9C2F09EBBF07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08808672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6CFDF8D-2642-DB43-BA79-D2BA03960C05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7806337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B228BB7-B5A4-40EB-8BB5-2B0C3AF6F6F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29BE44C-46E2-4FC0-94AC-96D170203B5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AB08EB8-C26E-4104-9283-D8BFD74401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54F5A9-7F61-4E01-9DBF-814AF148CDF2}" type="datetimeFigureOut">
              <a:rPr lang="en-ZA" smtClean="0"/>
              <a:t>2021/05/14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8FC578A-AF87-4275-893B-0E0FB5E82E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3BA9C20-C3B0-44B9-8907-50EDC1F673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057B4D-1C61-498D-BF55-F543F3CDF0C4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4644223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4E772CD-52F7-48F2-8CE0-4A21A66ADFC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2E3D2E5-975C-497A-B423-47E99AD6965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6AE5E1E-EB63-47D1-A8F4-FF5C0B3123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54F5A9-7F61-4E01-9DBF-814AF148CDF2}" type="datetimeFigureOut">
              <a:rPr lang="en-ZA" smtClean="0"/>
              <a:t>2021/05/14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68EB8E4-798D-4F77-B57E-8957024B37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57C9CBA-FDA6-4516-81F0-D52B3730A0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057B4D-1C61-498D-BF55-F543F3CDF0C4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6950723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DBACF17-C902-400C-80B0-175C2F87935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185A9FC-F378-4A3F-AAE1-6176F850C17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669CC05-3CA7-466D-899C-9D6CFC1780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54F5A9-7F61-4E01-9DBF-814AF148CDF2}" type="datetimeFigureOut">
              <a:rPr lang="en-ZA" smtClean="0"/>
              <a:t>2021/05/14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9AE053C-E138-4B49-88D7-4DE3F56F50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DC2806D-90D5-4964-BB01-EC4211804A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057B4D-1C61-498D-BF55-F543F3CDF0C4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1546959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2DAB2F6-173A-4874-8872-7756CE5D421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E0C408F-3EB1-4ACB-AFC9-0BBE9C03F37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BDC3EB7-68A1-4E85-9C96-508E3DE6E6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54F5A9-7F61-4E01-9DBF-814AF148CDF2}" type="datetimeFigureOut">
              <a:rPr lang="en-ZA" smtClean="0"/>
              <a:t>2021/05/14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7CB2D66-D404-4D11-AD4B-7AEA1C284B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9019C81-959E-46FF-B117-9845425055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057B4D-1C61-498D-BF55-F543F3CDF0C4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6118997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5D1D4DE-54BE-4B76-941F-BBFE9D32449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65D63AA-B1D8-4A42-AA22-A919CBA1E7E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88AC136-D7BA-40E6-812D-E8FC8B4516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54F5A9-7F61-4E01-9DBF-814AF148CDF2}" type="datetimeFigureOut">
              <a:rPr lang="en-ZA" smtClean="0"/>
              <a:t>2021/05/14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A78695A-E9A6-422F-8328-22EB4B7A83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CBFD552-7D43-4177-8872-57C1B53B7D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057B4D-1C61-498D-BF55-F543F3CDF0C4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2406791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9FA1764-1286-4674-9FC8-09F7B9C2FE8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C3E931D-8C8B-465C-8418-3D6D8F5BFB2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9BA590E-BC92-4EED-95BE-AA21068BB9F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17C64A8-FD7E-41CC-B70F-122F7B03E1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54F5A9-7F61-4E01-9DBF-814AF148CDF2}" type="datetimeFigureOut">
              <a:rPr lang="en-ZA" smtClean="0"/>
              <a:t>2021/05/14</a:t>
            </a:fld>
            <a:endParaRPr lang="en-Z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A83D0C3-C2F3-4466-9AAB-903B5B2BA8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8B897B1-2524-43FA-BC8D-956BBCB53E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057B4D-1C61-498D-BF55-F543F3CDF0C4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9675916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A734A8F-B05D-494E-8911-63B138CFBA8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F3BA8EF-54B8-4164-AD76-A5DE1861045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A7D718E-C3C3-4F21-B646-12462E6416C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18E4176-0C0C-47A4-A226-5B79C777BEF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DC96B4F-E1E1-4F41-BB55-F809240B0B1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FBD75D1-B1E1-4976-93ED-BE1225790F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54F5A9-7F61-4E01-9DBF-814AF148CDF2}" type="datetimeFigureOut">
              <a:rPr lang="en-ZA" smtClean="0"/>
              <a:t>2021/05/14</a:t>
            </a:fld>
            <a:endParaRPr lang="en-ZA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5D28047-338A-44D3-9907-4192F1AC83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8C0E81C-3C2C-48C7-9752-A809EED50D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057B4D-1C61-498D-BF55-F543F3CDF0C4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6710337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3100ADF-E5AA-4160-89C6-F1A46C7B265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912D203-729A-4703-BF22-1CDB872C55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54F5A9-7F61-4E01-9DBF-814AF148CDF2}" type="datetimeFigureOut">
              <a:rPr lang="en-ZA" smtClean="0"/>
              <a:t>2021/05/14</a:t>
            </a:fld>
            <a:endParaRPr lang="en-ZA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537EBCE-24B6-40DD-B9E9-30863C3AE9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7B85ED9-FC30-4EE0-A08E-ED95E72914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057B4D-1C61-498D-BF55-F543F3CDF0C4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6880348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5479ADE-87E5-4E91-904D-512ED946BF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54F5A9-7F61-4E01-9DBF-814AF148CDF2}" type="datetimeFigureOut">
              <a:rPr lang="en-ZA" smtClean="0"/>
              <a:t>2021/05/14</a:t>
            </a:fld>
            <a:endParaRPr lang="en-ZA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3606656-60BC-4C66-B760-A8C818C9D0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4565620-DAF5-4BE9-B166-F3D5419FF5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057B4D-1C61-498D-BF55-F543F3CDF0C4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5748351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013581C-909E-434C-B2F2-4D56C559FCF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5E2A368-CC68-4890-89D9-C21894D99D3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5359930-D902-4ED9-82E3-56F2E560F39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11248ED-FF77-46C8-AC11-093124E412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54F5A9-7F61-4E01-9DBF-814AF148CDF2}" type="datetimeFigureOut">
              <a:rPr lang="en-ZA" smtClean="0"/>
              <a:t>2021/05/14</a:t>
            </a:fld>
            <a:endParaRPr lang="en-Z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E5B33D1-BA55-41D7-9822-C48536F6FB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26160F5-E03C-4A8C-84C8-4362AD15F3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057B4D-1C61-498D-BF55-F543F3CDF0C4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6474470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2D6861A-48EC-4BF6-B6C5-F5113E84F65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63A74F4-13D7-48A7-89B5-228D0F46898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Z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6BF6AB7-87E6-4561-9E88-10587FF32F5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0F96259-CF3E-4CA2-A770-482172214E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54F5A9-7F61-4E01-9DBF-814AF148CDF2}" type="datetimeFigureOut">
              <a:rPr lang="en-ZA" smtClean="0"/>
              <a:t>2021/05/14</a:t>
            </a:fld>
            <a:endParaRPr lang="en-Z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D9C70DB-628D-4E41-8ED0-465FA7A7C0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7E828CA-51E6-4E9D-A8B8-2A0A143375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057B4D-1C61-498D-BF55-F543F3CDF0C4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4493150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DB66EAB-2269-4207-B29F-6E00A825BB7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CC8C442-BAFB-4B23-86BA-2DCCD6A3C80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67689A2-A8E5-4083-AFAE-5B99B12F4A7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54F5A9-7F61-4E01-9DBF-814AF148CDF2}" type="datetimeFigureOut">
              <a:rPr lang="en-ZA" smtClean="0"/>
              <a:t>2021/05/14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07BEECF-54B1-4B30-B7D8-8D3E570D8BA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4F17CDF-ED8F-46E3-8953-1227990BE86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057B4D-1C61-498D-BF55-F543F3CDF0C4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17431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ounded Rectangle 1">
            <a:extLst>
              <a:ext uri="{FF2B5EF4-FFF2-40B4-BE49-F238E27FC236}">
                <a16:creationId xmlns:a16="http://schemas.microsoft.com/office/drawing/2014/main" id="{1CDB9116-42AF-FB4F-A81B-8044BBEDB4D8}"/>
              </a:ext>
            </a:extLst>
          </p:cNvPr>
          <p:cNvSpPr/>
          <p:nvPr/>
        </p:nvSpPr>
        <p:spPr>
          <a:xfrm>
            <a:off x="1536192" y="1415325"/>
            <a:ext cx="1040508" cy="607890"/>
          </a:xfrm>
          <a:prstGeom prst="round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000" dirty="0">
                <a:solidFill>
                  <a:schemeClr val="tx1"/>
                </a:solidFill>
              </a:rPr>
              <a:t>Preventative behaviours</a:t>
            </a:r>
          </a:p>
        </p:txBody>
      </p:sp>
      <p:sp>
        <p:nvSpPr>
          <p:cNvPr id="3" name="Rounded Rectangle 2">
            <a:extLst>
              <a:ext uri="{FF2B5EF4-FFF2-40B4-BE49-F238E27FC236}">
                <a16:creationId xmlns:a16="http://schemas.microsoft.com/office/drawing/2014/main" id="{A7A9C7BB-33C9-0B41-8E20-971574B81653}"/>
              </a:ext>
            </a:extLst>
          </p:cNvPr>
          <p:cNvSpPr/>
          <p:nvPr/>
        </p:nvSpPr>
        <p:spPr>
          <a:xfrm>
            <a:off x="1536192" y="4112919"/>
            <a:ext cx="1040508" cy="607890"/>
          </a:xfrm>
          <a:prstGeom prst="round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000" dirty="0">
                <a:solidFill>
                  <a:schemeClr val="tx1"/>
                </a:solidFill>
              </a:rPr>
              <a:t>Preventative services</a:t>
            </a:r>
          </a:p>
        </p:txBody>
      </p:sp>
      <p:sp>
        <p:nvSpPr>
          <p:cNvPr id="4" name="Diamond 3">
            <a:extLst>
              <a:ext uri="{FF2B5EF4-FFF2-40B4-BE49-F238E27FC236}">
                <a16:creationId xmlns:a16="http://schemas.microsoft.com/office/drawing/2014/main" id="{85E00F6B-8A8A-DD48-97A0-266504807808}"/>
              </a:ext>
            </a:extLst>
          </p:cNvPr>
          <p:cNvSpPr/>
          <p:nvPr/>
        </p:nvSpPr>
        <p:spPr>
          <a:xfrm>
            <a:off x="1308100" y="2597060"/>
            <a:ext cx="1502613" cy="775599"/>
          </a:xfrm>
          <a:prstGeom prst="diamond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000" dirty="0">
                <a:solidFill>
                  <a:schemeClr val="tx1"/>
                </a:solidFill>
              </a:rPr>
              <a:t>Wellness</a:t>
            </a:r>
          </a:p>
        </p:txBody>
      </p:sp>
      <p:cxnSp>
        <p:nvCxnSpPr>
          <p:cNvPr id="7" name="Straight Connector 6">
            <a:extLst>
              <a:ext uri="{FF2B5EF4-FFF2-40B4-BE49-F238E27FC236}">
                <a16:creationId xmlns:a16="http://schemas.microsoft.com/office/drawing/2014/main" id="{A41DDF79-671C-B049-A0CE-19EB5FB03710}"/>
              </a:ext>
            </a:extLst>
          </p:cNvPr>
          <p:cNvCxnSpPr>
            <a:cxnSpLocks/>
          </p:cNvCxnSpPr>
          <p:nvPr/>
        </p:nvCxnSpPr>
        <p:spPr>
          <a:xfrm flipV="1">
            <a:off x="941832" y="3798570"/>
            <a:ext cx="10901905" cy="9144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>
            <a:extLst>
              <a:ext uri="{FF2B5EF4-FFF2-40B4-BE49-F238E27FC236}">
                <a16:creationId xmlns:a16="http://schemas.microsoft.com/office/drawing/2014/main" id="{89E8C44F-DCDC-4743-A073-CBF5DEB4FF07}"/>
              </a:ext>
            </a:extLst>
          </p:cNvPr>
          <p:cNvSpPr txBox="1"/>
          <p:nvPr/>
        </p:nvSpPr>
        <p:spPr>
          <a:xfrm>
            <a:off x="2919172" y="3539049"/>
            <a:ext cx="1170152" cy="276999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GB" sz="1200" dirty="0"/>
              <a:t>Inside home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8030991E-D731-CD4F-8600-10BDF367491F}"/>
              </a:ext>
            </a:extLst>
          </p:cNvPr>
          <p:cNvSpPr txBox="1"/>
          <p:nvPr/>
        </p:nvSpPr>
        <p:spPr>
          <a:xfrm>
            <a:off x="2908033" y="3816048"/>
            <a:ext cx="1311703" cy="276999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GB" sz="1200" dirty="0"/>
              <a:t>Outside home</a:t>
            </a:r>
          </a:p>
        </p:txBody>
      </p:sp>
      <p:cxnSp>
        <p:nvCxnSpPr>
          <p:cNvPr id="10" name="Straight Connector 9">
            <a:extLst>
              <a:ext uri="{FF2B5EF4-FFF2-40B4-BE49-F238E27FC236}">
                <a16:creationId xmlns:a16="http://schemas.microsoft.com/office/drawing/2014/main" id="{BF2E1E63-545A-B942-AB4C-A2E63A264955}"/>
              </a:ext>
            </a:extLst>
          </p:cNvPr>
          <p:cNvCxnSpPr>
            <a:cxnSpLocks/>
          </p:cNvCxnSpPr>
          <p:nvPr/>
        </p:nvCxnSpPr>
        <p:spPr>
          <a:xfrm>
            <a:off x="2895600" y="1415325"/>
            <a:ext cx="0" cy="5284939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Arrow Connector 13">
            <a:extLst>
              <a:ext uri="{FF2B5EF4-FFF2-40B4-BE49-F238E27FC236}">
                <a16:creationId xmlns:a16="http://schemas.microsoft.com/office/drawing/2014/main" id="{1913D34E-FD2D-5B44-BE98-D35398ECA608}"/>
              </a:ext>
            </a:extLst>
          </p:cNvPr>
          <p:cNvCxnSpPr>
            <a:cxnSpLocks/>
            <a:stCxn id="3" idx="0"/>
            <a:endCxn id="4" idx="2"/>
          </p:cNvCxnSpPr>
          <p:nvPr/>
        </p:nvCxnSpPr>
        <p:spPr>
          <a:xfrm flipV="1">
            <a:off x="2056446" y="3372659"/>
            <a:ext cx="2961" cy="74026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Arrow Connector 15">
            <a:extLst>
              <a:ext uri="{FF2B5EF4-FFF2-40B4-BE49-F238E27FC236}">
                <a16:creationId xmlns:a16="http://schemas.microsoft.com/office/drawing/2014/main" id="{174C9E97-1ADB-D942-AC77-F46373D5EDE5}"/>
              </a:ext>
            </a:extLst>
          </p:cNvPr>
          <p:cNvCxnSpPr>
            <a:cxnSpLocks/>
            <a:stCxn id="2" idx="2"/>
            <a:endCxn id="4" idx="0"/>
          </p:cNvCxnSpPr>
          <p:nvPr/>
        </p:nvCxnSpPr>
        <p:spPr>
          <a:xfrm>
            <a:off x="2056446" y="2023215"/>
            <a:ext cx="2961" cy="573845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Diamond 20">
            <a:extLst>
              <a:ext uri="{FF2B5EF4-FFF2-40B4-BE49-F238E27FC236}">
                <a16:creationId xmlns:a16="http://schemas.microsoft.com/office/drawing/2014/main" id="{73CA1692-2217-E34D-8F42-0ECAB1F2C5CD}"/>
              </a:ext>
            </a:extLst>
          </p:cNvPr>
          <p:cNvSpPr/>
          <p:nvPr/>
        </p:nvSpPr>
        <p:spPr>
          <a:xfrm>
            <a:off x="3085338" y="1383138"/>
            <a:ext cx="1502613" cy="775599"/>
          </a:xfrm>
          <a:prstGeom prst="diamond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000" dirty="0">
                <a:solidFill>
                  <a:schemeClr val="tx1"/>
                </a:solidFill>
              </a:rPr>
              <a:t>Illness</a:t>
            </a:r>
          </a:p>
        </p:txBody>
      </p:sp>
      <p:sp>
        <p:nvSpPr>
          <p:cNvPr id="22" name="Rounded Rectangle 21">
            <a:extLst>
              <a:ext uri="{FF2B5EF4-FFF2-40B4-BE49-F238E27FC236}">
                <a16:creationId xmlns:a16="http://schemas.microsoft.com/office/drawing/2014/main" id="{8062B2A8-4AA2-E24A-B09D-8E9B91385A52}"/>
              </a:ext>
            </a:extLst>
          </p:cNvPr>
          <p:cNvSpPr/>
          <p:nvPr/>
        </p:nvSpPr>
        <p:spPr>
          <a:xfrm>
            <a:off x="5035295" y="1470192"/>
            <a:ext cx="1040508" cy="607890"/>
          </a:xfrm>
          <a:prstGeom prst="roundRect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000" dirty="0">
                <a:solidFill>
                  <a:schemeClr val="tx1"/>
                </a:solidFill>
              </a:rPr>
              <a:t>Recognition in the home </a:t>
            </a:r>
          </a:p>
        </p:txBody>
      </p:sp>
      <p:sp>
        <p:nvSpPr>
          <p:cNvPr id="25" name="Rounded Rectangle 24">
            <a:extLst>
              <a:ext uri="{FF2B5EF4-FFF2-40B4-BE49-F238E27FC236}">
                <a16:creationId xmlns:a16="http://schemas.microsoft.com/office/drawing/2014/main" id="{AFE4AB30-C321-D74C-8C6A-600CAF319C22}"/>
              </a:ext>
            </a:extLst>
          </p:cNvPr>
          <p:cNvSpPr/>
          <p:nvPr/>
        </p:nvSpPr>
        <p:spPr>
          <a:xfrm>
            <a:off x="7149805" y="1461048"/>
            <a:ext cx="1040508" cy="607890"/>
          </a:xfrm>
          <a:prstGeom prst="roundRect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000" dirty="0">
                <a:solidFill>
                  <a:schemeClr val="tx1"/>
                </a:solidFill>
              </a:rPr>
              <a:t>Quality home care provided</a:t>
            </a:r>
          </a:p>
        </p:txBody>
      </p:sp>
      <p:sp>
        <p:nvSpPr>
          <p:cNvPr id="26" name="Rounded Rectangle 25">
            <a:extLst>
              <a:ext uri="{FF2B5EF4-FFF2-40B4-BE49-F238E27FC236}">
                <a16:creationId xmlns:a16="http://schemas.microsoft.com/office/drawing/2014/main" id="{D8027B2B-7452-5D43-BFD4-119F5CDB69AE}"/>
              </a:ext>
            </a:extLst>
          </p:cNvPr>
          <p:cNvSpPr/>
          <p:nvPr/>
        </p:nvSpPr>
        <p:spPr>
          <a:xfrm>
            <a:off x="5035295" y="2794550"/>
            <a:ext cx="1040508" cy="607890"/>
          </a:xfrm>
          <a:prstGeom prst="roundRect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000" dirty="0">
                <a:solidFill>
                  <a:schemeClr val="tx1"/>
                </a:solidFill>
              </a:rPr>
              <a:t>Recognition of severe illness in the home </a:t>
            </a:r>
          </a:p>
        </p:txBody>
      </p:sp>
      <p:sp>
        <p:nvSpPr>
          <p:cNvPr id="30" name="Rounded Rectangle 29">
            <a:extLst>
              <a:ext uri="{FF2B5EF4-FFF2-40B4-BE49-F238E27FC236}">
                <a16:creationId xmlns:a16="http://schemas.microsoft.com/office/drawing/2014/main" id="{ABA05B48-DA58-444B-80F0-D87010663DB3}"/>
              </a:ext>
            </a:extLst>
          </p:cNvPr>
          <p:cNvSpPr/>
          <p:nvPr/>
        </p:nvSpPr>
        <p:spPr>
          <a:xfrm>
            <a:off x="5029199" y="4545298"/>
            <a:ext cx="1045969" cy="607890"/>
          </a:xfrm>
          <a:custGeom>
            <a:avLst/>
            <a:gdLst>
              <a:gd name="connsiteX0" fmla="*/ 0 w 1161288"/>
              <a:gd name="connsiteY0" fmla="*/ 123446 h 740664"/>
              <a:gd name="connsiteX1" fmla="*/ 123446 w 1161288"/>
              <a:gd name="connsiteY1" fmla="*/ 0 h 740664"/>
              <a:gd name="connsiteX2" fmla="*/ 1037842 w 1161288"/>
              <a:gd name="connsiteY2" fmla="*/ 0 h 740664"/>
              <a:gd name="connsiteX3" fmla="*/ 1161288 w 1161288"/>
              <a:gd name="connsiteY3" fmla="*/ 123446 h 740664"/>
              <a:gd name="connsiteX4" fmla="*/ 1161288 w 1161288"/>
              <a:gd name="connsiteY4" fmla="*/ 617218 h 740664"/>
              <a:gd name="connsiteX5" fmla="*/ 1037842 w 1161288"/>
              <a:gd name="connsiteY5" fmla="*/ 740664 h 740664"/>
              <a:gd name="connsiteX6" fmla="*/ 123446 w 1161288"/>
              <a:gd name="connsiteY6" fmla="*/ 740664 h 740664"/>
              <a:gd name="connsiteX7" fmla="*/ 0 w 1161288"/>
              <a:gd name="connsiteY7" fmla="*/ 617218 h 740664"/>
              <a:gd name="connsiteX8" fmla="*/ 0 w 1161288"/>
              <a:gd name="connsiteY8" fmla="*/ 123446 h 740664"/>
              <a:gd name="connsiteX0" fmla="*/ 0 w 1161288"/>
              <a:gd name="connsiteY0" fmla="*/ 123446 h 740664"/>
              <a:gd name="connsiteX1" fmla="*/ 123446 w 1161288"/>
              <a:gd name="connsiteY1" fmla="*/ 0 h 740664"/>
              <a:gd name="connsiteX2" fmla="*/ 405385 w 1161288"/>
              <a:gd name="connsiteY2" fmla="*/ 2000 h 740664"/>
              <a:gd name="connsiteX3" fmla="*/ 1037842 w 1161288"/>
              <a:gd name="connsiteY3" fmla="*/ 0 h 740664"/>
              <a:gd name="connsiteX4" fmla="*/ 1161288 w 1161288"/>
              <a:gd name="connsiteY4" fmla="*/ 123446 h 740664"/>
              <a:gd name="connsiteX5" fmla="*/ 1161288 w 1161288"/>
              <a:gd name="connsiteY5" fmla="*/ 617218 h 740664"/>
              <a:gd name="connsiteX6" fmla="*/ 1037842 w 1161288"/>
              <a:gd name="connsiteY6" fmla="*/ 740664 h 740664"/>
              <a:gd name="connsiteX7" fmla="*/ 123446 w 1161288"/>
              <a:gd name="connsiteY7" fmla="*/ 740664 h 740664"/>
              <a:gd name="connsiteX8" fmla="*/ 0 w 1161288"/>
              <a:gd name="connsiteY8" fmla="*/ 617218 h 740664"/>
              <a:gd name="connsiteX9" fmla="*/ 0 w 1161288"/>
              <a:gd name="connsiteY9" fmla="*/ 123446 h 740664"/>
              <a:gd name="connsiteX0" fmla="*/ 0 w 1161288"/>
              <a:gd name="connsiteY0" fmla="*/ 123446 h 740664"/>
              <a:gd name="connsiteX1" fmla="*/ 123446 w 1161288"/>
              <a:gd name="connsiteY1" fmla="*/ 0 h 740664"/>
              <a:gd name="connsiteX2" fmla="*/ 1037842 w 1161288"/>
              <a:gd name="connsiteY2" fmla="*/ 0 h 740664"/>
              <a:gd name="connsiteX3" fmla="*/ 1161288 w 1161288"/>
              <a:gd name="connsiteY3" fmla="*/ 123446 h 740664"/>
              <a:gd name="connsiteX4" fmla="*/ 1161288 w 1161288"/>
              <a:gd name="connsiteY4" fmla="*/ 617218 h 740664"/>
              <a:gd name="connsiteX5" fmla="*/ 1037842 w 1161288"/>
              <a:gd name="connsiteY5" fmla="*/ 740664 h 740664"/>
              <a:gd name="connsiteX6" fmla="*/ 123446 w 1161288"/>
              <a:gd name="connsiteY6" fmla="*/ 740664 h 740664"/>
              <a:gd name="connsiteX7" fmla="*/ 0 w 1161288"/>
              <a:gd name="connsiteY7" fmla="*/ 617218 h 740664"/>
              <a:gd name="connsiteX8" fmla="*/ 0 w 1161288"/>
              <a:gd name="connsiteY8" fmla="*/ 123446 h 740664"/>
              <a:gd name="connsiteX0" fmla="*/ 0 w 1161288"/>
              <a:gd name="connsiteY0" fmla="*/ 123446 h 740664"/>
              <a:gd name="connsiteX1" fmla="*/ 123446 w 1161288"/>
              <a:gd name="connsiteY1" fmla="*/ 0 h 740664"/>
              <a:gd name="connsiteX2" fmla="*/ 387097 w 1161288"/>
              <a:gd name="connsiteY2" fmla="*/ 2000 h 740664"/>
              <a:gd name="connsiteX3" fmla="*/ 1037842 w 1161288"/>
              <a:gd name="connsiteY3" fmla="*/ 0 h 740664"/>
              <a:gd name="connsiteX4" fmla="*/ 1161288 w 1161288"/>
              <a:gd name="connsiteY4" fmla="*/ 123446 h 740664"/>
              <a:gd name="connsiteX5" fmla="*/ 1161288 w 1161288"/>
              <a:gd name="connsiteY5" fmla="*/ 617218 h 740664"/>
              <a:gd name="connsiteX6" fmla="*/ 1037842 w 1161288"/>
              <a:gd name="connsiteY6" fmla="*/ 740664 h 740664"/>
              <a:gd name="connsiteX7" fmla="*/ 123446 w 1161288"/>
              <a:gd name="connsiteY7" fmla="*/ 740664 h 740664"/>
              <a:gd name="connsiteX8" fmla="*/ 0 w 1161288"/>
              <a:gd name="connsiteY8" fmla="*/ 617218 h 740664"/>
              <a:gd name="connsiteX9" fmla="*/ 0 w 1161288"/>
              <a:gd name="connsiteY9" fmla="*/ 123446 h 740664"/>
              <a:gd name="connsiteX0" fmla="*/ 0 w 1161288"/>
              <a:gd name="connsiteY0" fmla="*/ 123446 h 740664"/>
              <a:gd name="connsiteX1" fmla="*/ 123446 w 1161288"/>
              <a:gd name="connsiteY1" fmla="*/ 0 h 740664"/>
              <a:gd name="connsiteX2" fmla="*/ 560833 w 1161288"/>
              <a:gd name="connsiteY2" fmla="*/ 2000 h 740664"/>
              <a:gd name="connsiteX3" fmla="*/ 1037842 w 1161288"/>
              <a:gd name="connsiteY3" fmla="*/ 0 h 740664"/>
              <a:gd name="connsiteX4" fmla="*/ 1161288 w 1161288"/>
              <a:gd name="connsiteY4" fmla="*/ 123446 h 740664"/>
              <a:gd name="connsiteX5" fmla="*/ 1161288 w 1161288"/>
              <a:gd name="connsiteY5" fmla="*/ 617218 h 740664"/>
              <a:gd name="connsiteX6" fmla="*/ 1037842 w 1161288"/>
              <a:gd name="connsiteY6" fmla="*/ 740664 h 740664"/>
              <a:gd name="connsiteX7" fmla="*/ 123446 w 1161288"/>
              <a:gd name="connsiteY7" fmla="*/ 740664 h 740664"/>
              <a:gd name="connsiteX8" fmla="*/ 0 w 1161288"/>
              <a:gd name="connsiteY8" fmla="*/ 617218 h 740664"/>
              <a:gd name="connsiteX9" fmla="*/ 0 w 1161288"/>
              <a:gd name="connsiteY9" fmla="*/ 123446 h 740664"/>
              <a:gd name="connsiteX0" fmla="*/ 6095 w 1167383"/>
              <a:gd name="connsiteY0" fmla="*/ 123446 h 740664"/>
              <a:gd name="connsiteX1" fmla="*/ 129541 w 1167383"/>
              <a:gd name="connsiteY1" fmla="*/ 0 h 740664"/>
              <a:gd name="connsiteX2" fmla="*/ 566928 w 1167383"/>
              <a:gd name="connsiteY2" fmla="*/ 2000 h 740664"/>
              <a:gd name="connsiteX3" fmla="*/ 1043937 w 1167383"/>
              <a:gd name="connsiteY3" fmla="*/ 0 h 740664"/>
              <a:gd name="connsiteX4" fmla="*/ 1167383 w 1167383"/>
              <a:gd name="connsiteY4" fmla="*/ 123446 h 740664"/>
              <a:gd name="connsiteX5" fmla="*/ 1167383 w 1167383"/>
              <a:gd name="connsiteY5" fmla="*/ 617218 h 740664"/>
              <a:gd name="connsiteX6" fmla="*/ 1043937 w 1167383"/>
              <a:gd name="connsiteY6" fmla="*/ 740664 h 740664"/>
              <a:gd name="connsiteX7" fmla="*/ 129541 w 1167383"/>
              <a:gd name="connsiteY7" fmla="*/ 740664 h 740664"/>
              <a:gd name="connsiteX8" fmla="*/ 6095 w 1167383"/>
              <a:gd name="connsiteY8" fmla="*/ 617218 h 740664"/>
              <a:gd name="connsiteX9" fmla="*/ 0 w 1167383"/>
              <a:gd name="connsiteY9" fmla="*/ 367760 h 740664"/>
              <a:gd name="connsiteX10" fmla="*/ 6095 w 1167383"/>
              <a:gd name="connsiteY10" fmla="*/ 123446 h 74066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</a:cxnLst>
            <a:rect l="l" t="t" r="r" b="b"/>
            <a:pathLst>
              <a:path w="1167383" h="740664">
                <a:moveTo>
                  <a:pt x="6095" y="123446"/>
                </a:moveTo>
                <a:cubicBezTo>
                  <a:pt x="6095" y="55269"/>
                  <a:pt x="61364" y="0"/>
                  <a:pt x="129541" y="0"/>
                </a:cubicBezTo>
                <a:lnTo>
                  <a:pt x="566928" y="2000"/>
                </a:lnTo>
                <a:lnTo>
                  <a:pt x="1043937" y="0"/>
                </a:lnTo>
                <a:cubicBezTo>
                  <a:pt x="1112114" y="0"/>
                  <a:pt x="1167383" y="55269"/>
                  <a:pt x="1167383" y="123446"/>
                </a:cubicBezTo>
                <a:lnTo>
                  <a:pt x="1167383" y="617218"/>
                </a:lnTo>
                <a:cubicBezTo>
                  <a:pt x="1167383" y="685395"/>
                  <a:pt x="1112114" y="740664"/>
                  <a:pt x="1043937" y="740664"/>
                </a:cubicBezTo>
                <a:lnTo>
                  <a:pt x="129541" y="740664"/>
                </a:lnTo>
                <a:cubicBezTo>
                  <a:pt x="61364" y="740664"/>
                  <a:pt x="6095" y="685395"/>
                  <a:pt x="6095" y="617218"/>
                </a:cubicBezTo>
                <a:lnTo>
                  <a:pt x="0" y="367760"/>
                </a:lnTo>
                <a:lnTo>
                  <a:pt x="6095" y="123446"/>
                </a:lnTo>
                <a:close/>
              </a:path>
            </a:pathLst>
          </a:cu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000" dirty="0">
                <a:solidFill>
                  <a:schemeClr val="tx1"/>
                </a:solidFill>
              </a:rPr>
              <a:t>Care accessed outside the home </a:t>
            </a:r>
          </a:p>
        </p:txBody>
      </p:sp>
      <p:cxnSp>
        <p:nvCxnSpPr>
          <p:cNvPr id="31" name="Straight Arrow Connector 30">
            <a:extLst>
              <a:ext uri="{FF2B5EF4-FFF2-40B4-BE49-F238E27FC236}">
                <a16:creationId xmlns:a16="http://schemas.microsoft.com/office/drawing/2014/main" id="{CDA5BD15-4BA0-6944-A5B6-DFD8F2033380}"/>
              </a:ext>
            </a:extLst>
          </p:cNvPr>
          <p:cNvCxnSpPr>
            <a:cxnSpLocks/>
            <a:stCxn id="21" idx="3"/>
            <a:endCxn id="22" idx="1"/>
          </p:cNvCxnSpPr>
          <p:nvPr/>
        </p:nvCxnSpPr>
        <p:spPr>
          <a:xfrm>
            <a:off x="4587951" y="1770938"/>
            <a:ext cx="447344" cy="3199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Straight Arrow Connector 33">
            <a:extLst>
              <a:ext uri="{FF2B5EF4-FFF2-40B4-BE49-F238E27FC236}">
                <a16:creationId xmlns:a16="http://schemas.microsoft.com/office/drawing/2014/main" id="{A65E1568-EB4E-1D42-B2E7-A11DD7856821}"/>
              </a:ext>
            </a:extLst>
          </p:cNvPr>
          <p:cNvCxnSpPr>
            <a:cxnSpLocks/>
            <a:stCxn id="22" idx="3"/>
            <a:endCxn id="25" idx="1"/>
          </p:cNvCxnSpPr>
          <p:nvPr/>
        </p:nvCxnSpPr>
        <p:spPr>
          <a:xfrm flipV="1">
            <a:off x="6075803" y="1764993"/>
            <a:ext cx="1074002" cy="9144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Arrow Connector 36">
            <a:extLst>
              <a:ext uri="{FF2B5EF4-FFF2-40B4-BE49-F238E27FC236}">
                <a16:creationId xmlns:a16="http://schemas.microsoft.com/office/drawing/2014/main" id="{658DB3F2-0ED1-2343-AB7B-8978554B3F23}"/>
              </a:ext>
            </a:extLst>
          </p:cNvPr>
          <p:cNvCxnSpPr>
            <a:cxnSpLocks/>
            <a:stCxn id="22" idx="2"/>
            <a:endCxn id="26" idx="0"/>
          </p:cNvCxnSpPr>
          <p:nvPr/>
        </p:nvCxnSpPr>
        <p:spPr>
          <a:xfrm>
            <a:off x="5555549" y="2078082"/>
            <a:ext cx="0" cy="71646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Arrow Connector 39">
            <a:extLst>
              <a:ext uri="{FF2B5EF4-FFF2-40B4-BE49-F238E27FC236}">
                <a16:creationId xmlns:a16="http://schemas.microsoft.com/office/drawing/2014/main" id="{73E1D526-53C7-9A4E-B9F3-D8ED9D32B66A}"/>
              </a:ext>
            </a:extLst>
          </p:cNvPr>
          <p:cNvCxnSpPr>
            <a:cxnSpLocks/>
          </p:cNvCxnSpPr>
          <p:nvPr/>
        </p:nvCxnSpPr>
        <p:spPr>
          <a:xfrm flipH="1">
            <a:off x="5573739" y="3402440"/>
            <a:ext cx="18386" cy="1144499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Elbow Connector 51">
            <a:extLst>
              <a:ext uri="{FF2B5EF4-FFF2-40B4-BE49-F238E27FC236}">
                <a16:creationId xmlns:a16="http://schemas.microsoft.com/office/drawing/2014/main" id="{426847C3-2336-A845-8529-B157B4875BCF}"/>
              </a:ext>
            </a:extLst>
          </p:cNvPr>
          <p:cNvCxnSpPr>
            <a:cxnSpLocks/>
            <a:stCxn id="25" idx="2"/>
            <a:endCxn id="26" idx="0"/>
          </p:cNvCxnSpPr>
          <p:nvPr/>
        </p:nvCxnSpPr>
        <p:spPr>
          <a:xfrm rot="5400000">
            <a:off x="6249998" y="1374489"/>
            <a:ext cx="725612" cy="2114510"/>
          </a:xfrm>
          <a:prstGeom prst="bentConnector3">
            <a:avLst>
              <a:gd name="adj1" fmla="val 50000"/>
            </a:avLst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" name="Diamond 54">
            <a:extLst>
              <a:ext uri="{FF2B5EF4-FFF2-40B4-BE49-F238E27FC236}">
                <a16:creationId xmlns:a16="http://schemas.microsoft.com/office/drawing/2014/main" id="{98AC76DD-66A6-8241-AA02-094ADF6292A9}"/>
              </a:ext>
            </a:extLst>
          </p:cNvPr>
          <p:cNvSpPr/>
          <p:nvPr/>
        </p:nvSpPr>
        <p:spPr>
          <a:xfrm>
            <a:off x="10041633" y="2619256"/>
            <a:ext cx="1802104" cy="775599"/>
          </a:xfrm>
          <a:prstGeom prst="diamond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000" dirty="0">
                <a:solidFill>
                  <a:schemeClr val="tx1"/>
                </a:solidFill>
              </a:rPr>
              <a:t>Improved health and survival</a:t>
            </a:r>
          </a:p>
        </p:txBody>
      </p:sp>
      <p:cxnSp>
        <p:nvCxnSpPr>
          <p:cNvPr id="56" name="Elbow Connector 55">
            <a:extLst>
              <a:ext uri="{FF2B5EF4-FFF2-40B4-BE49-F238E27FC236}">
                <a16:creationId xmlns:a16="http://schemas.microsoft.com/office/drawing/2014/main" id="{41FD2732-E134-2E4D-8D26-EFB933C56B9A}"/>
              </a:ext>
            </a:extLst>
          </p:cNvPr>
          <p:cNvCxnSpPr>
            <a:cxnSpLocks/>
            <a:stCxn id="25" idx="3"/>
            <a:endCxn id="55" idx="0"/>
          </p:cNvCxnSpPr>
          <p:nvPr/>
        </p:nvCxnSpPr>
        <p:spPr>
          <a:xfrm>
            <a:off x="8190313" y="1764993"/>
            <a:ext cx="2752372" cy="854263"/>
          </a:xfrm>
          <a:prstGeom prst="bentConnector2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Rounded Rectangle 58">
            <a:extLst>
              <a:ext uri="{FF2B5EF4-FFF2-40B4-BE49-F238E27FC236}">
                <a16:creationId xmlns:a16="http://schemas.microsoft.com/office/drawing/2014/main" id="{BA9C0AB5-EA1D-7F4C-AE4F-1F1A48C1ACD7}"/>
              </a:ext>
            </a:extLst>
          </p:cNvPr>
          <p:cNvSpPr/>
          <p:nvPr/>
        </p:nvSpPr>
        <p:spPr>
          <a:xfrm>
            <a:off x="7181472" y="2701806"/>
            <a:ext cx="1040508" cy="607890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000" dirty="0">
                <a:solidFill>
                  <a:schemeClr val="tx1"/>
                </a:solidFill>
              </a:rPr>
              <a:t>Home care recommenda-tions followed</a:t>
            </a:r>
          </a:p>
        </p:txBody>
      </p:sp>
      <p:sp>
        <p:nvSpPr>
          <p:cNvPr id="66" name="Rectangle 65">
            <a:extLst>
              <a:ext uri="{FF2B5EF4-FFF2-40B4-BE49-F238E27FC236}">
                <a16:creationId xmlns:a16="http://schemas.microsoft.com/office/drawing/2014/main" id="{2082C690-0B36-1B4A-B615-784851AE0F4F}"/>
              </a:ext>
            </a:extLst>
          </p:cNvPr>
          <p:cNvSpPr/>
          <p:nvPr/>
        </p:nvSpPr>
        <p:spPr>
          <a:xfrm>
            <a:off x="6807338" y="4224507"/>
            <a:ext cx="1216152" cy="561806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000" dirty="0">
                <a:solidFill>
                  <a:schemeClr val="tx1"/>
                </a:solidFill>
              </a:rPr>
              <a:t>Formal health services (public/private)</a:t>
            </a:r>
          </a:p>
        </p:txBody>
      </p:sp>
      <p:sp>
        <p:nvSpPr>
          <p:cNvPr id="67" name="Rectangle 66">
            <a:extLst>
              <a:ext uri="{FF2B5EF4-FFF2-40B4-BE49-F238E27FC236}">
                <a16:creationId xmlns:a16="http://schemas.microsoft.com/office/drawing/2014/main" id="{3281346A-1979-2D40-A4E0-52D91CD593EE}"/>
              </a:ext>
            </a:extLst>
          </p:cNvPr>
          <p:cNvSpPr/>
          <p:nvPr/>
        </p:nvSpPr>
        <p:spPr>
          <a:xfrm>
            <a:off x="6807338" y="5034135"/>
            <a:ext cx="1216152" cy="552760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000" dirty="0">
                <a:solidFill>
                  <a:schemeClr val="tx1"/>
                </a:solidFill>
              </a:rPr>
              <a:t>Informal community services</a:t>
            </a:r>
          </a:p>
        </p:txBody>
      </p:sp>
      <p:cxnSp>
        <p:nvCxnSpPr>
          <p:cNvPr id="68" name="Elbow Connector 67">
            <a:extLst>
              <a:ext uri="{FF2B5EF4-FFF2-40B4-BE49-F238E27FC236}">
                <a16:creationId xmlns:a16="http://schemas.microsoft.com/office/drawing/2014/main" id="{44204F1B-3DC1-4040-84CC-99C15AF3BEF1}"/>
              </a:ext>
            </a:extLst>
          </p:cNvPr>
          <p:cNvCxnSpPr>
            <a:cxnSpLocks/>
            <a:endCxn id="66" idx="1"/>
          </p:cNvCxnSpPr>
          <p:nvPr/>
        </p:nvCxnSpPr>
        <p:spPr>
          <a:xfrm flipV="1">
            <a:off x="6057310" y="4505410"/>
            <a:ext cx="750028" cy="360860"/>
          </a:xfrm>
          <a:prstGeom prst="bentConnector3">
            <a:avLst>
              <a:gd name="adj1" fmla="val 50000"/>
            </a:avLst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" name="Elbow Connector 70">
            <a:extLst>
              <a:ext uri="{FF2B5EF4-FFF2-40B4-BE49-F238E27FC236}">
                <a16:creationId xmlns:a16="http://schemas.microsoft.com/office/drawing/2014/main" id="{BFFCE54B-4BF8-BF40-A3DB-1DCE0F5FBFFA}"/>
              </a:ext>
            </a:extLst>
          </p:cNvPr>
          <p:cNvCxnSpPr>
            <a:cxnSpLocks/>
            <a:endCxn id="67" idx="1"/>
          </p:cNvCxnSpPr>
          <p:nvPr/>
        </p:nvCxnSpPr>
        <p:spPr>
          <a:xfrm>
            <a:off x="6057310" y="4849243"/>
            <a:ext cx="750028" cy="461272"/>
          </a:xfrm>
          <a:prstGeom prst="bentConnector3">
            <a:avLst>
              <a:gd name="adj1" fmla="val 50000"/>
            </a:avLst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4" name="Rounded Rectangle 73">
            <a:extLst>
              <a:ext uri="{FF2B5EF4-FFF2-40B4-BE49-F238E27FC236}">
                <a16:creationId xmlns:a16="http://schemas.microsoft.com/office/drawing/2014/main" id="{DC5BB781-A3CC-FC4A-A72D-08AC826914AA}"/>
              </a:ext>
            </a:extLst>
          </p:cNvPr>
          <p:cNvSpPr/>
          <p:nvPr/>
        </p:nvSpPr>
        <p:spPr>
          <a:xfrm>
            <a:off x="8700900" y="4525430"/>
            <a:ext cx="1089665" cy="607890"/>
          </a:xfrm>
          <a:prstGeom prst="roundRect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000" dirty="0">
                <a:solidFill>
                  <a:schemeClr val="tx1"/>
                </a:solidFill>
              </a:rPr>
              <a:t>Provider gives quality care</a:t>
            </a:r>
          </a:p>
        </p:txBody>
      </p:sp>
      <p:sp>
        <p:nvSpPr>
          <p:cNvPr id="75" name="Rounded Rectangle 74">
            <a:extLst>
              <a:ext uri="{FF2B5EF4-FFF2-40B4-BE49-F238E27FC236}">
                <a16:creationId xmlns:a16="http://schemas.microsoft.com/office/drawing/2014/main" id="{96AB6CBD-2A2D-3A4F-8236-12BE7CD77C60}"/>
              </a:ext>
            </a:extLst>
          </p:cNvPr>
          <p:cNvSpPr/>
          <p:nvPr/>
        </p:nvSpPr>
        <p:spPr>
          <a:xfrm>
            <a:off x="8700056" y="5316698"/>
            <a:ext cx="1089666" cy="607890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000" dirty="0">
                <a:solidFill>
                  <a:schemeClr val="tx1"/>
                </a:solidFill>
              </a:rPr>
              <a:t>Provider makes appropriate referral</a:t>
            </a:r>
          </a:p>
        </p:txBody>
      </p:sp>
      <p:cxnSp>
        <p:nvCxnSpPr>
          <p:cNvPr id="91" name="Elbow Connector 90">
            <a:extLst>
              <a:ext uri="{FF2B5EF4-FFF2-40B4-BE49-F238E27FC236}">
                <a16:creationId xmlns:a16="http://schemas.microsoft.com/office/drawing/2014/main" id="{51E37FCB-2AD4-0A40-873F-BDF94892BF94}"/>
              </a:ext>
            </a:extLst>
          </p:cNvPr>
          <p:cNvCxnSpPr>
            <a:cxnSpLocks/>
            <a:stCxn id="66" idx="3"/>
            <a:endCxn id="74" idx="1"/>
          </p:cNvCxnSpPr>
          <p:nvPr/>
        </p:nvCxnSpPr>
        <p:spPr>
          <a:xfrm>
            <a:off x="8023490" y="4505410"/>
            <a:ext cx="677410" cy="323965"/>
          </a:xfrm>
          <a:prstGeom prst="bentConnector3">
            <a:avLst>
              <a:gd name="adj1" fmla="val 50000"/>
            </a:avLst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4" name="Elbow Connector 93">
            <a:extLst>
              <a:ext uri="{FF2B5EF4-FFF2-40B4-BE49-F238E27FC236}">
                <a16:creationId xmlns:a16="http://schemas.microsoft.com/office/drawing/2014/main" id="{CE3C18EB-2442-4B4C-99C4-0E07274CDA81}"/>
              </a:ext>
            </a:extLst>
          </p:cNvPr>
          <p:cNvCxnSpPr>
            <a:cxnSpLocks/>
            <a:stCxn id="67" idx="3"/>
            <a:endCxn id="74" idx="1"/>
          </p:cNvCxnSpPr>
          <p:nvPr/>
        </p:nvCxnSpPr>
        <p:spPr>
          <a:xfrm flipV="1">
            <a:off x="8023490" y="4829375"/>
            <a:ext cx="677410" cy="481140"/>
          </a:xfrm>
          <a:prstGeom prst="bentConnector3">
            <a:avLst>
              <a:gd name="adj1" fmla="val 50000"/>
            </a:avLst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9" name="Straight Arrow Connector 98">
            <a:extLst>
              <a:ext uri="{FF2B5EF4-FFF2-40B4-BE49-F238E27FC236}">
                <a16:creationId xmlns:a16="http://schemas.microsoft.com/office/drawing/2014/main" id="{6B5E2EE6-0D0E-1D4D-90AF-AFC9CF4DD07C}"/>
              </a:ext>
            </a:extLst>
          </p:cNvPr>
          <p:cNvCxnSpPr>
            <a:cxnSpLocks/>
            <a:stCxn id="74" idx="2"/>
            <a:endCxn id="75" idx="0"/>
          </p:cNvCxnSpPr>
          <p:nvPr/>
        </p:nvCxnSpPr>
        <p:spPr>
          <a:xfrm flipH="1">
            <a:off x="9244889" y="5133320"/>
            <a:ext cx="844" cy="18337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2" name="Rounded Rectangle 101">
            <a:extLst>
              <a:ext uri="{FF2B5EF4-FFF2-40B4-BE49-F238E27FC236}">
                <a16:creationId xmlns:a16="http://schemas.microsoft.com/office/drawing/2014/main" id="{BCF58FB7-F665-1248-B429-DD0D3A9140D8}"/>
              </a:ext>
            </a:extLst>
          </p:cNvPr>
          <p:cNvSpPr/>
          <p:nvPr/>
        </p:nvSpPr>
        <p:spPr>
          <a:xfrm>
            <a:off x="5289402" y="6141347"/>
            <a:ext cx="1040508" cy="607890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000" dirty="0">
                <a:solidFill>
                  <a:schemeClr val="tx1"/>
                </a:solidFill>
              </a:rPr>
              <a:t>Referral facility  accessed </a:t>
            </a:r>
          </a:p>
        </p:txBody>
      </p:sp>
      <p:cxnSp>
        <p:nvCxnSpPr>
          <p:cNvPr id="108" name="Elbow Connector 107">
            <a:extLst>
              <a:ext uri="{FF2B5EF4-FFF2-40B4-BE49-F238E27FC236}">
                <a16:creationId xmlns:a16="http://schemas.microsoft.com/office/drawing/2014/main" id="{C6841FB0-E6C1-BB47-85FA-CC1F2B86D300}"/>
              </a:ext>
            </a:extLst>
          </p:cNvPr>
          <p:cNvCxnSpPr>
            <a:cxnSpLocks/>
            <a:stCxn id="75" idx="2"/>
            <a:endCxn id="102" idx="0"/>
          </p:cNvCxnSpPr>
          <p:nvPr/>
        </p:nvCxnSpPr>
        <p:spPr>
          <a:xfrm rot="5400000">
            <a:off x="7418894" y="4315351"/>
            <a:ext cx="216759" cy="3435233"/>
          </a:xfrm>
          <a:prstGeom prst="bentConnector3">
            <a:avLst>
              <a:gd name="adj1" fmla="val 50000"/>
            </a:avLst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1" name="Rectangle 110">
            <a:extLst>
              <a:ext uri="{FF2B5EF4-FFF2-40B4-BE49-F238E27FC236}">
                <a16:creationId xmlns:a16="http://schemas.microsoft.com/office/drawing/2014/main" id="{730FB1DE-E6E5-004C-9C46-5505AAFAD5DF}"/>
              </a:ext>
            </a:extLst>
          </p:cNvPr>
          <p:cNvSpPr/>
          <p:nvPr/>
        </p:nvSpPr>
        <p:spPr>
          <a:xfrm>
            <a:off x="6816421" y="6195048"/>
            <a:ext cx="1216152" cy="505216"/>
          </a:xfrm>
          <a:prstGeom prst="rect">
            <a:avLst/>
          </a:prstGeom>
          <a:noFill/>
          <a:ln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000" dirty="0">
                <a:solidFill>
                  <a:schemeClr val="tx1"/>
                </a:solidFill>
              </a:rPr>
              <a:t>Referral facility</a:t>
            </a:r>
          </a:p>
        </p:txBody>
      </p:sp>
      <p:sp>
        <p:nvSpPr>
          <p:cNvPr id="112" name="Rounded Rectangle 111">
            <a:extLst>
              <a:ext uri="{FF2B5EF4-FFF2-40B4-BE49-F238E27FC236}">
                <a16:creationId xmlns:a16="http://schemas.microsoft.com/office/drawing/2014/main" id="{EE5594A1-CFEB-734A-BB63-C3C15932FDA4}"/>
              </a:ext>
            </a:extLst>
          </p:cNvPr>
          <p:cNvSpPr/>
          <p:nvPr/>
        </p:nvSpPr>
        <p:spPr>
          <a:xfrm>
            <a:off x="8645192" y="6141224"/>
            <a:ext cx="1089665" cy="607890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000" dirty="0">
                <a:solidFill>
                  <a:schemeClr val="tx1"/>
                </a:solidFill>
              </a:rPr>
              <a:t>Provider gives quality care</a:t>
            </a:r>
          </a:p>
        </p:txBody>
      </p:sp>
      <p:cxnSp>
        <p:nvCxnSpPr>
          <p:cNvPr id="113" name="Elbow Connector 112">
            <a:extLst>
              <a:ext uri="{FF2B5EF4-FFF2-40B4-BE49-F238E27FC236}">
                <a16:creationId xmlns:a16="http://schemas.microsoft.com/office/drawing/2014/main" id="{3AE38029-25FF-5841-802B-29FD3B38195A}"/>
              </a:ext>
            </a:extLst>
          </p:cNvPr>
          <p:cNvCxnSpPr>
            <a:cxnSpLocks/>
            <a:stCxn id="74" idx="3"/>
            <a:endCxn id="55" idx="2"/>
          </p:cNvCxnSpPr>
          <p:nvPr/>
        </p:nvCxnSpPr>
        <p:spPr>
          <a:xfrm flipV="1">
            <a:off x="9790565" y="3394855"/>
            <a:ext cx="1152120" cy="1434520"/>
          </a:xfrm>
          <a:prstGeom prst="bentConnector2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6" name="Elbow Connector 115">
            <a:extLst>
              <a:ext uri="{FF2B5EF4-FFF2-40B4-BE49-F238E27FC236}">
                <a16:creationId xmlns:a16="http://schemas.microsoft.com/office/drawing/2014/main" id="{08BE0C63-035E-4240-9D4B-0871BF46768A}"/>
              </a:ext>
            </a:extLst>
          </p:cNvPr>
          <p:cNvCxnSpPr>
            <a:cxnSpLocks/>
            <a:stCxn id="112" idx="3"/>
            <a:endCxn id="55" idx="2"/>
          </p:cNvCxnSpPr>
          <p:nvPr/>
        </p:nvCxnSpPr>
        <p:spPr>
          <a:xfrm flipV="1">
            <a:off x="9734857" y="3394855"/>
            <a:ext cx="1207828" cy="3050314"/>
          </a:xfrm>
          <a:prstGeom prst="bentConnector2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9" name="Straight Arrow Connector 118">
            <a:extLst>
              <a:ext uri="{FF2B5EF4-FFF2-40B4-BE49-F238E27FC236}">
                <a16:creationId xmlns:a16="http://schemas.microsoft.com/office/drawing/2014/main" id="{E8281404-1407-C147-9C76-446ACF8BB8F4}"/>
              </a:ext>
            </a:extLst>
          </p:cNvPr>
          <p:cNvCxnSpPr>
            <a:cxnSpLocks/>
            <a:stCxn id="102" idx="3"/>
            <a:endCxn id="111" idx="1"/>
          </p:cNvCxnSpPr>
          <p:nvPr/>
        </p:nvCxnSpPr>
        <p:spPr>
          <a:xfrm>
            <a:off x="6329910" y="6445292"/>
            <a:ext cx="486511" cy="2364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2" name="Straight Arrow Connector 121">
            <a:extLst>
              <a:ext uri="{FF2B5EF4-FFF2-40B4-BE49-F238E27FC236}">
                <a16:creationId xmlns:a16="http://schemas.microsoft.com/office/drawing/2014/main" id="{EA294D80-5B01-D94C-9A3C-32424DC60D85}"/>
              </a:ext>
            </a:extLst>
          </p:cNvPr>
          <p:cNvCxnSpPr>
            <a:cxnSpLocks/>
            <a:stCxn id="111" idx="3"/>
            <a:endCxn id="112" idx="1"/>
          </p:cNvCxnSpPr>
          <p:nvPr/>
        </p:nvCxnSpPr>
        <p:spPr>
          <a:xfrm flipV="1">
            <a:off x="8032573" y="6445169"/>
            <a:ext cx="612619" cy="248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5" name="Straight Arrow Connector 124">
            <a:extLst>
              <a:ext uri="{FF2B5EF4-FFF2-40B4-BE49-F238E27FC236}">
                <a16:creationId xmlns:a16="http://schemas.microsoft.com/office/drawing/2014/main" id="{E204926B-1182-7440-BE47-78F47C7639E8}"/>
              </a:ext>
            </a:extLst>
          </p:cNvPr>
          <p:cNvCxnSpPr>
            <a:cxnSpLocks/>
            <a:stCxn id="59" idx="3"/>
            <a:endCxn id="55" idx="1"/>
          </p:cNvCxnSpPr>
          <p:nvPr/>
        </p:nvCxnSpPr>
        <p:spPr>
          <a:xfrm>
            <a:off x="8221980" y="3005751"/>
            <a:ext cx="1819653" cy="1305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8" name="Elbow Connector 127">
            <a:extLst>
              <a:ext uri="{FF2B5EF4-FFF2-40B4-BE49-F238E27FC236}">
                <a16:creationId xmlns:a16="http://schemas.microsoft.com/office/drawing/2014/main" id="{481295DB-99BE-EB43-BB3A-F4D29C6F3E4F}"/>
              </a:ext>
            </a:extLst>
          </p:cNvPr>
          <p:cNvCxnSpPr>
            <a:cxnSpLocks/>
            <a:stCxn id="278" idx="9"/>
            <a:endCxn id="59" idx="2"/>
          </p:cNvCxnSpPr>
          <p:nvPr/>
        </p:nvCxnSpPr>
        <p:spPr>
          <a:xfrm flipH="1" flipV="1">
            <a:off x="7701726" y="3309696"/>
            <a:ext cx="3225736" cy="419857"/>
          </a:xfrm>
          <a:prstGeom prst="bentConnector4">
            <a:avLst>
              <a:gd name="adj1" fmla="val -567"/>
              <a:gd name="adj2" fmla="val 72"/>
            </a:avLst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6" name="Elbow Connector 185">
            <a:extLst>
              <a:ext uri="{FF2B5EF4-FFF2-40B4-BE49-F238E27FC236}">
                <a16:creationId xmlns:a16="http://schemas.microsoft.com/office/drawing/2014/main" id="{70900E96-2C20-3543-B43F-CCABAB88A2B2}"/>
              </a:ext>
            </a:extLst>
          </p:cNvPr>
          <p:cNvCxnSpPr>
            <a:cxnSpLocks/>
            <a:stCxn id="59" idx="1"/>
            <a:endCxn id="26" idx="0"/>
          </p:cNvCxnSpPr>
          <p:nvPr/>
        </p:nvCxnSpPr>
        <p:spPr>
          <a:xfrm rot="10800000">
            <a:off x="5555550" y="2794551"/>
            <a:ext cx="1625923" cy="211201"/>
          </a:xfrm>
          <a:prstGeom prst="bentConnector4">
            <a:avLst>
              <a:gd name="adj1" fmla="val 34001"/>
              <a:gd name="adj2" fmla="val 273181"/>
            </a:avLst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7" name="Elbow Connector 216">
            <a:extLst>
              <a:ext uri="{FF2B5EF4-FFF2-40B4-BE49-F238E27FC236}">
                <a16:creationId xmlns:a16="http://schemas.microsoft.com/office/drawing/2014/main" id="{1646B876-A191-5542-A3A5-C2E3E812C3F4}"/>
              </a:ext>
            </a:extLst>
          </p:cNvPr>
          <p:cNvCxnSpPr>
            <a:cxnSpLocks/>
            <a:stCxn id="22" idx="2"/>
            <a:endCxn id="257" idx="9"/>
          </p:cNvCxnSpPr>
          <p:nvPr/>
        </p:nvCxnSpPr>
        <p:spPr>
          <a:xfrm rot="16200000" flipH="1">
            <a:off x="4800586" y="2833044"/>
            <a:ext cx="1563079" cy="53153"/>
          </a:xfrm>
          <a:prstGeom prst="bentConnector4">
            <a:avLst>
              <a:gd name="adj1" fmla="val 22461"/>
              <a:gd name="adj2" fmla="val -1664749"/>
            </a:avLst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7" name="Rounded Rectangle 29">
            <a:extLst>
              <a:ext uri="{FF2B5EF4-FFF2-40B4-BE49-F238E27FC236}">
                <a16:creationId xmlns:a16="http://schemas.microsoft.com/office/drawing/2014/main" id="{18B09FC4-8A52-6940-A3A9-A9F1F73509C9}"/>
              </a:ext>
            </a:extLst>
          </p:cNvPr>
          <p:cNvSpPr/>
          <p:nvPr/>
        </p:nvSpPr>
        <p:spPr>
          <a:xfrm>
            <a:off x="5608702" y="3475204"/>
            <a:ext cx="543311" cy="334236"/>
          </a:xfrm>
          <a:custGeom>
            <a:avLst/>
            <a:gdLst>
              <a:gd name="connsiteX0" fmla="*/ 0 w 1161288"/>
              <a:gd name="connsiteY0" fmla="*/ 123446 h 740664"/>
              <a:gd name="connsiteX1" fmla="*/ 123446 w 1161288"/>
              <a:gd name="connsiteY1" fmla="*/ 0 h 740664"/>
              <a:gd name="connsiteX2" fmla="*/ 1037842 w 1161288"/>
              <a:gd name="connsiteY2" fmla="*/ 0 h 740664"/>
              <a:gd name="connsiteX3" fmla="*/ 1161288 w 1161288"/>
              <a:gd name="connsiteY3" fmla="*/ 123446 h 740664"/>
              <a:gd name="connsiteX4" fmla="*/ 1161288 w 1161288"/>
              <a:gd name="connsiteY4" fmla="*/ 617218 h 740664"/>
              <a:gd name="connsiteX5" fmla="*/ 1037842 w 1161288"/>
              <a:gd name="connsiteY5" fmla="*/ 740664 h 740664"/>
              <a:gd name="connsiteX6" fmla="*/ 123446 w 1161288"/>
              <a:gd name="connsiteY6" fmla="*/ 740664 h 740664"/>
              <a:gd name="connsiteX7" fmla="*/ 0 w 1161288"/>
              <a:gd name="connsiteY7" fmla="*/ 617218 h 740664"/>
              <a:gd name="connsiteX8" fmla="*/ 0 w 1161288"/>
              <a:gd name="connsiteY8" fmla="*/ 123446 h 740664"/>
              <a:gd name="connsiteX0" fmla="*/ 0 w 1161288"/>
              <a:gd name="connsiteY0" fmla="*/ 123446 h 740664"/>
              <a:gd name="connsiteX1" fmla="*/ 123446 w 1161288"/>
              <a:gd name="connsiteY1" fmla="*/ 0 h 740664"/>
              <a:gd name="connsiteX2" fmla="*/ 405385 w 1161288"/>
              <a:gd name="connsiteY2" fmla="*/ 2000 h 740664"/>
              <a:gd name="connsiteX3" fmla="*/ 1037842 w 1161288"/>
              <a:gd name="connsiteY3" fmla="*/ 0 h 740664"/>
              <a:gd name="connsiteX4" fmla="*/ 1161288 w 1161288"/>
              <a:gd name="connsiteY4" fmla="*/ 123446 h 740664"/>
              <a:gd name="connsiteX5" fmla="*/ 1161288 w 1161288"/>
              <a:gd name="connsiteY5" fmla="*/ 617218 h 740664"/>
              <a:gd name="connsiteX6" fmla="*/ 1037842 w 1161288"/>
              <a:gd name="connsiteY6" fmla="*/ 740664 h 740664"/>
              <a:gd name="connsiteX7" fmla="*/ 123446 w 1161288"/>
              <a:gd name="connsiteY7" fmla="*/ 740664 h 740664"/>
              <a:gd name="connsiteX8" fmla="*/ 0 w 1161288"/>
              <a:gd name="connsiteY8" fmla="*/ 617218 h 740664"/>
              <a:gd name="connsiteX9" fmla="*/ 0 w 1161288"/>
              <a:gd name="connsiteY9" fmla="*/ 123446 h 740664"/>
              <a:gd name="connsiteX0" fmla="*/ 0 w 1161288"/>
              <a:gd name="connsiteY0" fmla="*/ 123446 h 740664"/>
              <a:gd name="connsiteX1" fmla="*/ 123446 w 1161288"/>
              <a:gd name="connsiteY1" fmla="*/ 0 h 740664"/>
              <a:gd name="connsiteX2" fmla="*/ 1037842 w 1161288"/>
              <a:gd name="connsiteY2" fmla="*/ 0 h 740664"/>
              <a:gd name="connsiteX3" fmla="*/ 1161288 w 1161288"/>
              <a:gd name="connsiteY3" fmla="*/ 123446 h 740664"/>
              <a:gd name="connsiteX4" fmla="*/ 1161288 w 1161288"/>
              <a:gd name="connsiteY4" fmla="*/ 617218 h 740664"/>
              <a:gd name="connsiteX5" fmla="*/ 1037842 w 1161288"/>
              <a:gd name="connsiteY5" fmla="*/ 740664 h 740664"/>
              <a:gd name="connsiteX6" fmla="*/ 123446 w 1161288"/>
              <a:gd name="connsiteY6" fmla="*/ 740664 h 740664"/>
              <a:gd name="connsiteX7" fmla="*/ 0 w 1161288"/>
              <a:gd name="connsiteY7" fmla="*/ 617218 h 740664"/>
              <a:gd name="connsiteX8" fmla="*/ 0 w 1161288"/>
              <a:gd name="connsiteY8" fmla="*/ 123446 h 740664"/>
              <a:gd name="connsiteX0" fmla="*/ 0 w 1161288"/>
              <a:gd name="connsiteY0" fmla="*/ 123446 h 740664"/>
              <a:gd name="connsiteX1" fmla="*/ 123446 w 1161288"/>
              <a:gd name="connsiteY1" fmla="*/ 0 h 740664"/>
              <a:gd name="connsiteX2" fmla="*/ 387097 w 1161288"/>
              <a:gd name="connsiteY2" fmla="*/ 2000 h 740664"/>
              <a:gd name="connsiteX3" fmla="*/ 1037842 w 1161288"/>
              <a:gd name="connsiteY3" fmla="*/ 0 h 740664"/>
              <a:gd name="connsiteX4" fmla="*/ 1161288 w 1161288"/>
              <a:gd name="connsiteY4" fmla="*/ 123446 h 740664"/>
              <a:gd name="connsiteX5" fmla="*/ 1161288 w 1161288"/>
              <a:gd name="connsiteY5" fmla="*/ 617218 h 740664"/>
              <a:gd name="connsiteX6" fmla="*/ 1037842 w 1161288"/>
              <a:gd name="connsiteY6" fmla="*/ 740664 h 740664"/>
              <a:gd name="connsiteX7" fmla="*/ 123446 w 1161288"/>
              <a:gd name="connsiteY7" fmla="*/ 740664 h 740664"/>
              <a:gd name="connsiteX8" fmla="*/ 0 w 1161288"/>
              <a:gd name="connsiteY8" fmla="*/ 617218 h 740664"/>
              <a:gd name="connsiteX9" fmla="*/ 0 w 1161288"/>
              <a:gd name="connsiteY9" fmla="*/ 123446 h 740664"/>
              <a:gd name="connsiteX0" fmla="*/ 0 w 1161288"/>
              <a:gd name="connsiteY0" fmla="*/ 123446 h 740664"/>
              <a:gd name="connsiteX1" fmla="*/ 123446 w 1161288"/>
              <a:gd name="connsiteY1" fmla="*/ 0 h 740664"/>
              <a:gd name="connsiteX2" fmla="*/ 560833 w 1161288"/>
              <a:gd name="connsiteY2" fmla="*/ 2000 h 740664"/>
              <a:gd name="connsiteX3" fmla="*/ 1037842 w 1161288"/>
              <a:gd name="connsiteY3" fmla="*/ 0 h 740664"/>
              <a:gd name="connsiteX4" fmla="*/ 1161288 w 1161288"/>
              <a:gd name="connsiteY4" fmla="*/ 123446 h 740664"/>
              <a:gd name="connsiteX5" fmla="*/ 1161288 w 1161288"/>
              <a:gd name="connsiteY5" fmla="*/ 617218 h 740664"/>
              <a:gd name="connsiteX6" fmla="*/ 1037842 w 1161288"/>
              <a:gd name="connsiteY6" fmla="*/ 740664 h 740664"/>
              <a:gd name="connsiteX7" fmla="*/ 123446 w 1161288"/>
              <a:gd name="connsiteY7" fmla="*/ 740664 h 740664"/>
              <a:gd name="connsiteX8" fmla="*/ 0 w 1161288"/>
              <a:gd name="connsiteY8" fmla="*/ 617218 h 740664"/>
              <a:gd name="connsiteX9" fmla="*/ 0 w 1161288"/>
              <a:gd name="connsiteY9" fmla="*/ 123446 h 740664"/>
              <a:gd name="connsiteX0" fmla="*/ 6095 w 1167383"/>
              <a:gd name="connsiteY0" fmla="*/ 123446 h 740664"/>
              <a:gd name="connsiteX1" fmla="*/ 129541 w 1167383"/>
              <a:gd name="connsiteY1" fmla="*/ 0 h 740664"/>
              <a:gd name="connsiteX2" fmla="*/ 566928 w 1167383"/>
              <a:gd name="connsiteY2" fmla="*/ 2000 h 740664"/>
              <a:gd name="connsiteX3" fmla="*/ 1043937 w 1167383"/>
              <a:gd name="connsiteY3" fmla="*/ 0 h 740664"/>
              <a:gd name="connsiteX4" fmla="*/ 1167383 w 1167383"/>
              <a:gd name="connsiteY4" fmla="*/ 123446 h 740664"/>
              <a:gd name="connsiteX5" fmla="*/ 1167383 w 1167383"/>
              <a:gd name="connsiteY5" fmla="*/ 617218 h 740664"/>
              <a:gd name="connsiteX6" fmla="*/ 1043937 w 1167383"/>
              <a:gd name="connsiteY6" fmla="*/ 740664 h 740664"/>
              <a:gd name="connsiteX7" fmla="*/ 129541 w 1167383"/>
              <a:gd name="connsiteY7" fmla="*/ 740664 h 740664"/>
              <a:gd name="connsiteX8" fmla="*/ 6095 w 1167383"/>
              <a:gd name="connsiteY8" fmla="*/ 617218 h 740664"/>
              <a:gd name="connsiteX9" fmla="*/ 0 w 1167383"/>
              <a:gd name="connsiteY9" fmla="*/ 367760 h 740664"/>
              <a:gd name="connsiteX10" fmla="*/ 6095 w 1167383"/>
              <a:gd name="connsiteY10" fmla="*/ 123446 h 74066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</a:cxnLst>
            <a:rect l="l" t="t" r="r" b="b"/>
            <a:pathLst>
              <a:path w="1167383" h="740664">
                <a:moveTo>
                  <a:pt x="6095" y="123446"/>
                </a:moveTo>
                <a:cubicBezTo>
                  <a:pt x="6095" y="55269"/>
                  <a:pt x="61364" y="0"/>
                  <a:pt x="129541" y="0"/>
                </a:cubicBezTo>
                <a:lnTo>
                  <a:pt x="566928" y="2000"/>
                </a:lnTo>
                <a:lnTo>
                  <a:pt x="1043937" y="0"/>
                </a:lnTo>
                <a:cubicBezTo>
                  <a:pt x="1112114" y="0"/>
                  <a:pt x="1167383" y="55269"/>
                  <a:pt x="1167383" y="123446"/>
                </a:cubicBezTo>
                <a:lnTo>
                  <a:pt x="1167383" y="617218"/>
                </a:lnTo>
                <a:cubicBezTo>
                  <a:pt x="1167383" y="685395"/>
                  <a:pt x="1112114" y="740664"/>
                  <a:pt x="1043937" y="740664"/>
                </a:cubicBezTo>
                <a:lnTo>
                  <a:pt x="129541" y="740664"/>
                </a:lnTo>
                <a:cubicBezTo>
                  <a:pt x="61364" y="740664"/>
                  <a:pt x="6095" y="685395"/>
                  <a:pt x="6095" y="617218"/>
                </a:cubicBezTo>
                <a:lnTo>
                  <a:pt x="0" y="367760"/>
                </a:lnTo>
                <a:lnTo>
                  <a:pt x="6095" y="123446"/>
                </a:lnTo>
                <a:close/>
              </a:path>
            </a:pathLst>
          </a:cu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>
              <a:tabLst>
                <a:tab pos="479425" algn="l"/>
              </a:tabLst>
            </a:pPr>
            <a:endParaRPr lang="en-GB" sz="1200" dirty="0">
              <a:solidFill>
                <a:schemeClr val="tx1"/>
              </a:solidFill>
            </a:endParaRPr>
          </a:p>
        </p:txBody>
      </p:sp>
      <p:cxnSp>
        <p:nvCxnSpPr>
          <p:cNvPr id="265" name="Elbow Connector 264">
            <a:extLst>
              <a:ext uri="{FF2B5EF4-FFF2-40B4-BE49-F238E27FC236}">
                <a16:creationId xmlns:a16="http://schemas.microsoft.com/office/drawing/2014/main" id="{0B1DA574-AE8E-B448-901E-CB9E6A95B0B3}"/>
              </a:ext>
            </a:extLst>
          </p:cNvPr>
          <p:cNvCxnSpPr>
            <a:cxnSpLocks/>
            <a:stCxn id="59" idx="1"/>
            <a:endCxn id="257" idx="9"/>
          </p:cNvCxnSpPr>
          <p:nvPr/>
        </p:nvCxnSpPr>
        <p:spPr>
          <a:xfrm rot="10800000" flipV="1">
            <a:off x="5608702" y="3005751"/>
            <a:ext cx="1572770" cy="635410"/>
          </a:xfrm>
          <a:prstGeom prst="bentConnector3">
            <a:avLst>
              <a:gd name="adj1" fmla="val 34884"/>
            </a:avLst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8" name="Rounded Rectangle 29">
            <a:extLst>
              <a:ext uri="{FF2B5EF4-FFF2-40B4-BE49-F238E27FC236}">
                <a16:creationId xmlns:a16="http://schemas.microsoft.com/office/drawing/2014/main" id="{4B508B24-348B-2545-B60A-7AB951CB6B0D}"/>
              </a:ext>
            </a:extLst>
          </p:cNvPr>
          <p:cNvSpPr/>
          <p:nvPr/>
        </p:nvSpPr>
        <p:spPr>
          <a:xfrm>
            <a:off x="10927462" y="3563596"/>
            <a:ext cx="543311" cy="334236"/>
          </a:xfrm>
          <a:custGeom>
            <a:avLst/>
            <a:gdLst>
              <a:gd name="connsiteX0" fmla="*/ 0 w 1161288"/>
              <a:gd name="connsiteY0" fmla="*/ 123446 h 740664"/>
              <a:gd name="connsiteX1" fmla="*/ 123446 w 1161288"/>
              <a:gd name="connsiteY1" fmla="*/ 0 h 740664"/>
              <a:gd name="connsiteX2" fmla="*/ 1037842 w 1161288"/>
              <a:gd name="connsiteY2" fmla="*/ 0 h 740664"/>
              <a:gd name="connsiteX3" fmla="*/ 1161288 w 1161288"/>
              <a:gd name="connsiteY3" fmla="*/ 123446 h 740664"/>
              <a:gd name="connsiteX4" fmla="*/ 1161288 w 1161288"/>
              <a:gd name="connsiteY4" fmla="*/ 617218 h 740664"/>
              <a:gd name="connsiteX5" fmla="*/ 1037842 w 1161288"/>
              <a:gd name="connsiteY5" fmla="*/ 740664 h 740664"/>
              <a:gd name="connsiteX6" fmla="*/ 123446 w 1161288"/>
              <a:gd name="connsiteY6" fmla="*/ 740664 h 740664"/>
              <a:gd name="connsiteX7" fmla="*/ 0 w 1161288"/>
              <a:gd name="connsiteY7" fmla="*/ 617218 h 740664"/>
              <a:gd name="connsiteX8" fmla="*/ 0 w 1161288"/>
              <a:gd name="connsiteY8" fmla="*/ 123446 h 740664"/>
              <a:gd name="connsiteX0" fmla="*/ 0 w 1161288"/>
              <a:gd name="connsiteY0" fmla="*/ 123446 h 740664"/>
              <a:gd name="connsiteX1" fmla="*/ 123446 w 1161288"/>
              <a:gd name="connsiteY1" fmla="*/ 0 h 740664"/>
              <a:gd name="connsiteX2" fmla="*/ 405385 w 1161288"/>
              <a:gd name="connsiteY2" fmla="*/ 2000 h 740664"/>
              <a:gd name="connsiteX3" fmla="*/ 1037842 w 1161288"/>
              <a:gd name="connsiteY3" fmla="*/ 0 h 740664"/>
              <a:gd name="connsiteX4" fmla="*/ 1161288 w 1161288"/>
              <a:gd name="connsiteY4" fmla="*/ 123446 h 740664"/>
              <a:gd name="connsiteX5" fmla="*/ 1161288 w 1161288"/>
              <a:gd name="connsiteY5" fmla="*/ 617218 h 740664"/>
              <a:gd name="connsiteX6" fmla="*/ 1037842 w 1161288"/>
              <a:gd name="connsiteY6" fmla="*/ 740664 h 740664"/>
              <a:gd name="connsiteX7" fmla="*/ 123446 w 1161288"/>
              <a:gd name="connsiteY7" fmla="*/ 740664 h 740664"/>
              <a:gd name="connsiteX8" fmla="*/ 0 w 1161288"/>
              <a:gd name="connsiteY8" fmla="*/ 617218 h 740664"/>
              <a:gd name="connsiteX9" fmla="*/ 0 w 1161288"/>
              <a:gd name="connsiteY9" fmla="*/ 123446 h 740664"/>
              <a:gd name="connsiteX0" fmla="*/ 0 w 1161288"/>
              <a:gd name="connsiteY0" fmla="*/ 123446 h 740664"/>
              <a:gd name="connsiteX1" fmla="*/ 123446 w 1161288"/>
              <a:gd name="connsiteY1" fmla="*/ 0 h 740664"/>
              <a:gd name="connsiteX2" fmla="*/ 1037842 w 1161288"/>
              <a:gd name="connsiteY2" fmla="*/ 0 h 740664"/>
              <a:gd name="connsiteX3" fmla="*/ 1161288 w 1161288"/>
              <a:gd name="connsiteY3" fmla="*/ 123446 h 740664"/>
              <a:gd name="connsiteX4" fmla="*/ 1161288 w 1161288"/>
              <a:gd name="connsiteY4" fmla="*/ 617218 h 740664"/>
              <a:gd name="connsiteX5" fmla="*/ 1037842 w 1161288"/>
              <a:gd name="connsiteY5" fmla="*/ 740664 h 740664"/>
              <a:gd name="connsiteX6" fmla="*/ 123446 w 1161288"/>
              <a:gd name="connsiteY6" fmla="*/ 740664 h 740664"/>
              <a:gd name="connsiteX7" fmla="*/ 0 w 1161288"/>
              <a:gd name="connsiteY7" fmla="*/ 617218 h 740664"/>
              <a:gd name="connsiteX8" fmla="*/ 0 w 1161288"/>
              <a:gd name="connsiteY8" fmla="*/ 123446 h 740664"/>
              <a:gd name="connsiteX0" fmla="*/ 0 w 1161288"/>
              <a:gd name="connsiteY0" fmla="*/ 123446 h 740664"/>
              <a:gd name="connsiteX1" fmla="*/ 123446 w 1161288"/>
              <a:gd name="connsiteY1" fmla="*/ 0 h 740664"/>
              <a:gd name="connsiteX2" fmla="*/ 387097 w 1161288"/>
              <a:gd name="connsiteY2" fmla="*/ 2000 h 740664"/>
              <a:gd name="connsiteX3" fmla="*/ 1037842 w 1161288"/>
              <a:gd name="connsiteY3" fmla="*/ 0 h 740664"/>
              <a:gd name="connsiteX4" fmla="*/ 1161288 w 1161288"/>
              <a:gd name="connsiteY4" fmla="*/ 123446 h 740664"/>
              <a:gd name="connsiteX5" fmla="*/ 1161288 w 1161288"/>
              <a:gd name="connsiteY5" fmla="*/ 617218 h 740664"/>
              <a:gd name="connsiteX6" fmla="*/ 1037842 w 1161288"/>
              <a:gd name="connsiteY6" fmla="*/ 740664 h 740664"/>
              <a:gd name="connsiteX7" fmla="*/ 123446 w 1161288"/>
              <a:gd name="connsiteY7" fmla="*/ 740664 h 740664"/>
              <a:gd name="connsiteX8" fmla="*/ 0 w 1161288"/>
              <a:gd name="connsiteY8" fmla="*/ 617218 h 740664"/>
              <a:gd name="connsiteX9" fmla="*/ 0 w 1161288"/>
              <a:gd name="connsiteY9" fmla="*/ 123446 h 740664"/>
              <a:gd name="connsiteX0" fmla="*/ 0 w 1161288"/>
              <a:gd name="connsiteY0" fmla="*/ 123446 h 740664"/>
              <a:gd name="connsiteX1" fmla="*/ 123446 w 1161288"/>
              <a:gd name="connsiteY1" fmla="*/ 0 h 740664"/>
              <a:gd name="connsiteX2" fmla="*/ 560833 w 1161288"/>
              <a:gd name="connsiteY2" fmla="*/ 2000 h 740664"/>
              <a:gd name="connsiteX3" fmla="*/ 1037842 w 1161288"/>
              <a:gd name="connsiteY3" fmla="*/ 0 h 740664"/>
              <a:gd name="connsiteX4" fmla="*/ 1161288 w 1161288"/>
              <a:gd name="connsiteY4" fmla="*/ 123446 h 740664"/>
              <a:gd name="connsiteX5" fmla="*/ 1161288 w 1161288"/>
              <a:gd name="connsiteY5" fmla="*/ 617218 h 740664"/>
              <a:gd name="connsiteX6" fmla="*/ 1037842 w 1161288"/>
              <a:gd name="connsiteY6" fmla="*/ 740664 h 740664"/>
              <a:gd name="connsiteX7" fmla="*/ 123446 w 1161288"/>
              <a:gd name="connsiteY7" fmla="*/ 740664 h 740664"/>
              <a:gd name="connsiteX8" fmla="*/ 0 w 1161288"/>
              <a:gd name="connsiteY8" fmla="*/ 617218 h 740664"/>
              <a:gd name="connsiteX9" fmla="*/ 0 w 1161288"/>
              <a:gd name="connsiteY9" fmla="*/ 123446 h 740664"/>
              <a:gd name="connsiteX0" fmla="*/ 6095 w 1167383"/>
              <a:gd name="connsiteY0" fmla="*/ 123446 h 740664"/>
              <a:gd name="connsiteX1" fmla="*/ 129541 w 1167383"/>
              <a:gd name="connsiteY1" fmla="*/ 0 h 740664"/>
              <a:gd name="connsiteX2" fmla="*/ 566928 w 1167383"/>
              <a:gd name="connsiteY2" fmla="*/ 2000 h 740664"/>
              <a:gd name="connsiteX3" fmla="*/ 1043937 w 1167383"/>
              <a:gd name="connsiteY3" fmla="*/ 0 h 740664"/>
              <a:gd name="connsiteX4" fmla="*/ 1167383 w 1167383"/>
              <a:gd name="connsiteY4" fmla="*/ 123446 h 740664"/>
              <a:gd name="connsiteX5" fmla="*/ 1167383 w 1167383"/>
              <a:gd name="connsiteY5" fmla="*/ 617218 h 740664"/>
              <a:gd name="connsiteX6" fmla="*/ 1043937 w 1167383"/>
              <a:gd name="connsiteY6" fmla="*/ 740664 h 740664"/>
              <a:gd name="connsiteX7" fmla="*/ 129541 w 1167383"/>
              <a:gd name="connsiteY7" fmla="*/ 740664 h 740664"/>
              <a:gd name="connsiteX8" fmla="*/ 6095 w 1167383"/>
              <a:gd name="connsiteY8" fmla="*/ 617218 h 740664"/>
              <a:gd name="connsiteX9" fmla="*/ 0 w 1167383"/>
              <a:gd name="connsiteY9" fmla="*/ 367760 h 740664"/>
              <a:gd name="connsiteX10" fmla="*/ 6095 w 1167383"/>
              <a:gd name="connsiteY10" fmla="*/ 123446 h 74066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</a:cxnLst>
            <a:rect l="l" t="t" r="r" b="b"/>
            <a:pathLst>
              <a:path w="1167383" h="740664">
                <a:moveTo>
                  <a:pt x="6095" y="123446"/>
                </a:moveTo>
                <a:cubicBezTo>
                  <a:pt x="6095" y="55269"/>
                  <a:pt x="61364" y="0"/>
                  <a:pt x="129541" y="0"/>
                </a:cubicBezTo>
                <a:lnTo>
                  <a:pt x="566928" y="2000"/>
                </a:lnTo>
                <a:lnTo>
                  <a:pt x="1043937" y="0"/>
                </a:lnTo>
                <a:cubicBezTo>
                  <a:pt x="1112114" y="0"/>
                  <a:pt x="1167383" y="55269"/>
                  <a:pt x="1167383" y="123446"/>
                </a:cubicBezTo>
                <a:lnTo>
                  <a:pt x="1167383" y="617218"/>
                </a:lnTo>
                <a:cubicBezTo>
                  <a:pt x="1167383" y="685395"/>
                  <a:pt x="1112114" y="740664"/>
                  <a:pt x="1043937" y="740664"/>
                </a:cubicBezTo>
                <a:lnTo>
                  <a:pt x="129541" y="740664"/>
                </a:lnTo>
                <a:cubicBezTo>
                  <a:pt x="61364" y="740664"/>
                  <a:pt x="6095" y="685395"/>
                  <a:pt x="6095" y="617218"/>
                </a:cubicBezTo>
                <a:lnTo>
                  <a:pt x="0" y="367760"/>
                </a:lnTo>
                <a:lnTo>
                  <a:pt x="6095" y="123446"/>
                </a:lnTo>
                <a:close/>
              </a:path>
            </a:pathLst>
          </a:cu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>
              <a:tabLst>
                <a:tab pos="479425" algn="l"/>
              </a:tabLst>
            </a:pPr>
            <a:endParaRPr lang="en-GB" sz="1200" dirty="0">
              <a:solidFill>
                <a:schemeClr val="tx1"/>
              </a:solidFill>
            </a:endParaRPr>
          </a:p>
        </p:txBody>
      </p:sp>
      <p:sp>
        <p:nvSpPr>
          <p:cNvPr id="298" name="Oval Callout 297">
            <a:extLst>
              <a:ext uri="{FF2B5EF4-FFF2-40B4-BE49-F238E27FC236}">
                <a16:creationId xmlns:a16="http://schemas.microsoft.com/office/drawing/2014/main" id="{2EB71360-30EA-2C4A-BB4C-09A81F427CED}"/>
              </a:ext>
            </a:extLst>
          </p:cNvPr>
          <p:cNvSpPr/>
          <p:nvPr/>
        </p:nvSpPr>
        <p:spPr>
          <a:xfrm>
            <a:off x="3139284" y="2657274"/>
            <a:ext cx="1305120" cy="741356"/>
          </a:xfrm>
          <a:prstGeom prst="wedgeEllipseCallout">
            <a:avLst>
              <a:gd name="adj1" fmla="val 59020"/>
              <a:gd name="adj2" fmla="val -152853"/>
            </a:avLst>
          </a:prstGeom>
          <a:solidFill>
            <a:srgbClr val="FF999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800" dirty="0">
              <a:solidFill>
                <a:schemeClr val="tx1"/>
              </a:solidFill>
            </a:endParaRPr>
          </a:p>
        </p:txBody>
      </p:sp>
      <p:sp>
        <p:nvSpPr>
          <p:cNvPr id="297" name="Oval Callout 296">
            <a:extLst>
              <a:ext uri="{FF2B5EF4-FFF2-40B4-BE49-F238E27FC236}">
                <a16:creationId xmlns:a16="http://schemas.microsoft.com/office/drawing/2014/main" id="{D89D24E0-3954-3E49-9446-69CEDE02A51E}"/>
              </a:ext>
            </a:extLst>
          </p:cNvPr>
          <p:cNvSpPr/>
          <p:nvPr/>
        </p:nvSpPr>
        <p:spPr>
          <a:xfrm>
            <a:off x="3136520" y="2642571"/>
            <a:ext cx="1305120" cy="741356"/>
          </a:xfrm>
          <a:prstGeom prst="wedgeEllipseCallout">
            <a:avLst>
              <a:gd name="adj1" fmla="val 120946"/>
              <a:gd name="adj2" fmla="val -63320"/>
            </a:avLst>
          </a:prstGeom>
          <a:solidFill>
            <a:srgbClr val="FF999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200" dirty="0">
                <a:solidFill>
                  <a:schemeClr val="tx1"/>
                </a:solidFill>
              </a:rPr>
              <a:t>Recognition</a:t>
            </a:r>
          </a:p>
        </p:txBody>
      </p:sp>
      <p:sp>
        <p:nvSpPr>
          <p:cNvPr id="299" name="Oval Callout 298">
            <a:extLst>
              <a:ext uri="{FF2B5EF4-FFF2-40B4-BE49-F238E27FC236}">
                <a16:creationId xmlns:a16="http://schemas.microsoft.com/office/drawing/2014/main" id="{EAFC78C6-9186-8C4E-9D1F-93F2B95D93D4}"/>
              </a:ext>
            </a:extLst>
          </p:cNvPr>
          <p:cNvSpPr/>
          <p:nvPr/>
        </p:nvSpPr>
        <p:spPr>
          <a:xfrm>
            <a:off x="6711741" y="326621"/>
            <a:ext cx="1305120" cy="741356"/>
          </a:xfrm>
          <a:prstGeom prst="wedgeEllipseCallout">
            <a:avLst>
              <a:gd name="adj1" fmla="val -58571"/>
              <a:gd name="adj2" fmla="val 122529"/>
            </a:avLst>
          </a:prstGeom>
          <a:solidFill>
            <a:srgbClr val="FF999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200" dirty="0">
                <a:solidFill>
                  <a:schemeClr val="tx1"/>
                </a:solidFill>
              </a:rPr>
              <a:t>Traditions</a:t>
            </a:r>
          </a:p>
        </p:txBody>
      </p:sp>
      <p:sp>
        <p:nvSpPr>
          <p:cNvPr id="304" name="Oval Callout 303">
            <a:extLst>
              <a:ext uri="{FF2B5EF4-FFF2-40B4-BE49-F238E27FC236}">
                <a16:creationId xmlns:a16="http://schemas.microsoft.com/office/drawing/2014/main" id="{B81778CA-FF6A-214A-AF89-809F642C9217}"/>
              </a:ext>
            </a:extLst>
          </p:cNvPr>
          <p:cNvSpPr/>
          <p:nvPr/>
        </p:nvSpPr>
        <p:spPr>
          <a:xfrm>
            <a:off x="3065378" y="4152013"/>
            <a:ext cx="1305120" cy="741356"/>
          </a:xfrm>
          <a:prstGeom prst="wedgeEllipseCallout">
            <a:avLst>
              <a:gd name="adj1" fmla="val 120946"/>
              <a:gd name="adj2" fmla="val -80955"/>
            </a:avLst>
          </a:prstGeom>
          <a:solidFill>
            <a:srgbClr val="FF999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200" dirty="0">
                <a:solidFill>
                  <a:schemeClr val="tx1"/>
                </a:solidFill>
              </a:rPr>
              <a:t>Accessing care</a:t>
            </a:r>
          </a:p>
        </p:txBody>
      </p:sp>
      <p:sp>
        <p:nvSpPr>
          <p:cNvPr id="305" name="Oval Callout 304">
            <a:extLst>
              <a:ext uri="{FF2B5EF4-FFF2-40B4-BE49-F238E27FC236}">
                <a16:creationId xmlns:a16="http://schemas.microsoft.com/office/drawing/2014/main" id="{410D8EAF-155B-EC4D-AB63-DDE7A028C310}"/>
              </a:ext>
            </a:extLst>
          </p:cNvPr>
          <p:cNvSpPr/>
          <p:nvPr/>
        </p:nvSpPr>
        <p:spPr>
          <a:xfrm>
            <a:off x="3290521" y="5099125"/>
            <a:ext cx="1305120" cy="741356"/>
          </a:xfrm>
          <a:prstGeom prst="wedgeEllipseCallout">
            <a:avLst>
              <a:gd name="adj1" fmla="val 110509"/>
              <a:gd name="adj2" fmla="val -196262"/>
            </a:avLst>
          </a:prstGeom>
          <a:solidFill>
            <a:srgbClr val="FF999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200" dirty="0">
                <a:solidFill>
                  <a:schemeClr val="tx1"/>
                </a:solidFill>
              </a:rPr>
              <a:t>Emergency</a:t>
            </a:r>
          </a:p>
        </p:txBody>
      </p:sp>
      <p:sp>
        <p:nvSpPr>
          <p:cNvPr id="306" name="Oval Callout 305">
            <a:extLst>
              <a:ext uri="{FF2B5EF4-FFF2-40B4-BE49-F238E27FC236}">
                <a16:creationId xmlns:a16="http://schemas.microsoft.com/office/drawing/2014/main" id="{6F4960D9-C1BA-2148-B49B-A94F7FDFA253}"/>
              </a:ext>
            </a:extLst>
          </p:cNvPr>
          <p:cNvSpPr/>
          <p:nvPr/>
        </p:nvSpPr>
        <p:spPr>
          <a:xfrm>
            <a:off x="3959705" y="5903390"/>
            <a:ext cx="1305120" cy="741356"/>
          </a:xfrm>
          <a:prstGeom prst="wedgeEllipseCallout">
            <a:avLst>
              <a:gd name="adj1" fmla="val 139732"/>
              <a:gd name="adj2" fmla="val -182697"/>
            </a:avLst>
          </a:prstGeom>
          <a:solidFill>
            <a:srgbClr val="FF999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200" dirty="0">
                <a:solidFill>
                  <a:schemeClr val="tx1"/>
                </a:solidFill>
              </a:rPr>
              <a:t>Traditions</a:t>
            </a:r>
          </a:p>
        </p:txBody>
      </p:sp>
      <p:sp>
        <p:nvSpPr>
          <p:cNvPr id="307" name="Oval Callout 306">
            <a:extLst>
              <a:ext uri="{FF2B5EF4-FFF2-40B4-BE49-F238E27FC236}">
                <a16:creationId xmlns:a16="http://schemas.microsoft.com/office/drawing/2014/main" id="{72CBDD94-11E5-6145-8F22-AE4E10833BBA}"/>
              </a:ext>
            </a:extLst>
          </p:cNvPr>
          <p:cNvSpPr/>
          <p:nvPr/>
        </p:nvSpPr>
        <p:spPr>
          <a:xfrm>
            <a:off x="8721291" y="3309696"/>
            <a:ext cx="1305120" cy="741356"/>
          </a:xfrm>
          <a:prstGeom prst="wedgeEllipseCallout">
            <a:avLst>
              <a:gd name="adj1" fmla="val 40952"/>
              <a:gd name="adj2" fmla="val 127792"/>
            </a:avLst>
          </a:prstGeom>
          <a:solidFill>
            <a:srgbClr val="FF999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800" dirty="0">
              <a:solidFill>
                <a:schemeClr val="tx1"/>
              </a:solidFill>
            </a:endParaRPr>
          </a:p>
        </p:txBody>
      </p:sp>
      <p:sp>
        <p:nvSpPr>
          <p:cNvPr id="308" name="Oval Callout 307">
            <a:extLst>
              <a:ext uri="{FF2B5EF4-FFF2-40B4-BE49-F238E27FC236}">
                <a16:creationId xmlns:a16="http://schemas.microsoft.com/office/drawing/2014/main" id="{3DC31AC6-C7D9-F843-9DAD-38FA20834964}"/>
              </a:ext>
            </a:extLst>
          </p:cNvPr>
          <p:cNvSpPr/>
          <p:nvPr/>
        </p:nvSpPr>
        <p:spPr>
          <a:xfrm>
            <a:off x="8724744" y="3316274"/>
            <a:ext cx="1305120" cy="741356"/>
          </a:xfrm>
          <a:prstGeom prst="wedgeEllipseCallout">
            <a:avLst>
              <a:gd name="adj1" fmla="val -68466"/>
              <a:gd name="adj2" fmla="val 127628"/>
            </a:avLst>
          </a:prstGeom>
          <a:solidFill>
            <a:srgbClr val="FF999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800" dirty="0">
              <a:solidFill>
                <a:schemeClr val="tx1"/>
              </a:solidFill>
            </a:endParaRPr>
          </a:p>
        </p:txBody>
      </p:sp>
      <p:sp>
        <p:nvSpPr>
          <p:cNvPr id="394" name="Oval Callout 393">
            <a:extLst>
              <a:ext uri="{FF2B5EF4-FFF2-40B4-BE49-F238E27FC236}">
                <a16:creationId xmlns:a16="http://schemas.microsoft.com/office/drawing/2014/main" id="{1A42BB68-E324-6D48-B74E-CA1B2F3F80FD}"/>
              </a:ext>
            </a:extLst>
          </p:cNvPr>
          <p:cNvSpPr/>
          <p:nvPr/>
        </p:nvSpPr>
        <p:spPr>
          <a:xfrm>
            <a:off x="8731186" y="3295379"/>
            <a:ext cx="1305120" cy="741356"/>
          </a:xfrm>
          <a:prstGeom prst="wedgeEllipseCallout">
            <a:avLst>
              <a:gd name="adj1" fmla="val -242583"/>
              <a:gd name="adj2" fmla="val 28475"/>
            </a:avLst>
          </a:prstGeom>
          <a:solidFill>
            <a:srgbClr val="FF999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200" dirty="0">
                <a:solidFill>
                  <a:schemeClr val="tx1"/>
                </a:solidFill>
              </a:rPr>
              <a:t>Perceived quality</a:t>
            </a: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B1CFB1E2-A5D2-BD4A-A12F-55427D7BE27D}"/>
              </a:ext>
            </a:extLst>
          </p:cNvPr>
          <p:cNvSpPr txBox="1"/>
          <p:nvPr/>
        </p:nvSpPr>
        <p:spPr>
          <a:xfrm>
            <a:off x="219351" y="297055"/>
            <a:ext cx="4278610" cy="90024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Supplementary Material 2</a:t>
            </a:r>
            <a:r>
              <a:rPr lang="en-GB" sz="1050" i="1" dirty="0"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Circumstance of Mortality Categories (COMCATs) arranged by the Pathways to Survival framework (adapted from </a:t>
            </a:r>
            <a:r>
              <a:rPr lang="en-ZA" sz="1050" baseline="30000" dirty="0">
                <a:latin typeface="Arial" panose="020B0604020202020204" pitchFamily="34" charset="0"/>
                <a:cs typeface="Arial" panose="020B0604020202020204" pitchFamily="34" charset="0"/>
              </a:rPr>
              <a:t>43</a:t>
            </a:r>
            <a:r>
              <a:rPr lang="en-ZA" sz="105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  <a:p>
            <a:endParaRPr lang="en-GB" sz="1050" i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GB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8392620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64</TotalTime>
  <Words>98</Words>
  <Application>Microsoft Macintosh PowerPoint</Application>
  <PresentationFormat>Widescreen</PresentationFormat>
  <Paragraphs>27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essica Price</dc:creator>
  <cp:lastModifiedBy>D'Ambruoso, Lucia</cp:lastModifiedBy>
  <cp:revision>19</cp:revision>
  <dcterms:created xsi:type="dcterms:W3CDTF">2021-03-08T15:24:13Z</dcterms:created>
  <dcterms:modified xsi:type="dcterms:W3CDTF">2021-05-14T15:23:52Z</dcterms:modified>
</cp:coreProperties>
</file>